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79417" autoAdjust="0"/>
  </p:normalViewPr>
  <p:slideViewPr>
    <p:cSldViewPr snapToGrid="0" showGuides="1">
      <p:cViewPr varScale="1">
        <p:scale>
          <a:sx n="82" d="100"/>
          <a:sy n="82" d="100"/>
        </p:scale>
        <p:origin x="120" y="32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yung Pyo Kang" userId="736d9d377d64be0f" providerId="LiveId" clId="{6C3449C0-F0B0-48DA-9F7F-072D2CA690A3}"/>
    <pc:docChg chg="modSld">
      <pc:chgData name="Kyung Pyo Kang" userId="736d9d377d64be0f" providerId="LiveId" clId="{6C3449C0-F0B0-48DA-9F7F-072D2CA690A3}" dt="2025-05-19T14:37:42.216" v="52" actId="113"/>
      <pc:docMkLst>
        <pc:docMk/>
      </pc:docMkLst>
      <pc:sldChg chg="addSp modSp mod modNotesTx">
        <pc:chgData name="Kyung Pyo Kang" userId="736d9d377d64be0f" providerId="LiveId" clId="{6C3449C0-F0B0-48DA-9F7F-072D2CA690A3}" dt="2025-05-19T14:37:42.216" v="52" actId="113"/>
        <pc:sldMkLst>
          <pc:docMk/>
          <pc:sldMk cId="3616487984" sldId="257"/>
        </pc:sldMkLst>
        <pc:spChg chg="add mod">
          <ac:chgData name="Kyung Pyo Kang" userId="736d9d377d64be0f" providerId="LiveId" clId="{6C3449C0-F0B0-48DA-9F7F-072D2CA690A3}" dt="2025-05-19T14:37:42.216" v="52" actId="113"/>
          <ac:spMkLst>
            <pc:docMk/>
            <pc:sldMk cId="3616487984" sldId="257"/>
            <ac:spMk id="4" creationId="{13A34D4F-2268-B4A9-3394-8A8340A3D296}"/>
          </ac:spMkLst>
        </pc:spChg>
        <pc:spChg chg="mod">
          <ac:chgData name="Kyung Pyo Kang" userId="736d9d377d64be0f" providerId="LiveId" clId="{6C3449C0-F0B0-48DA-9F7F-072D2CA690A3}" dt="2025-05-19T14:36:34.358" v="47" actId="1076"/>
          <ac:spMkLst>
            <pc:docMk/>
            <pc:sldMk cId="3616487984" sldId="257"/>
            <ac:spMk id="6" creationId="{A8AA564D-44B7-77DD-F563-B87B64381E3A}"/>
          </ac:spMkLst>
        </pc:spChg>
        <pc:picChg chg="mod">
          <ac:chgData name="Kyung Pyo Kang" userId="736d9d377d64be0f" providerId="LiveId" clId="{6C3449C0-F0B0-48DA-9F7F-072D2CA690A3}" dt="2025-05-19T14:36:23.892" v="45" actId="1076"/>
          <ac:picMkLst>
            <pc:docMk/>
            <pc:sldMk cId="3616487984" sldId="257"/>
            <ac:picMk id="2" creationId="{79CAA958-11F5-8050-FB4C-06A6BFAB1921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8F951A0-B429-4A8C-91EA-8A245442AADE}" type="datetimeFigureOut">
              <a:rPr lang="ko-KR" altLang="en-US" smtClean="0"/>
              <a:t>2025-05-19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7D678AD-BFE5-401F-80B8-86C93E82632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578690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D01C8B9-51DE-49F4-9E97-C8CFEFA468C2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339080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ED0AB79-308F-E032-5AEC-C2011B183D3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462AFF13-D2BE-7F93-302A-2E9165AA541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996DCEB-EC54-4ACF-3496-5AAB11F000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C1346-754F-455F-B174-E84FB53D968E}" type="datetimeFigureOut">
              <a:rPr lang="ko-KR" altLang="en-US" smtClean="0"/>
              <a:t>2025-05-1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40832DC-F43B-92D4-1746-396846FAD3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BA73D9FD-1455-9812-5D5D-DA9BCEF3CA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40D77-CA82-4AC0-809E-D018214D5F0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679113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C1E5169-C4F5-D63C-84E3-670A41FA9E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0CD1C33B-51B6-AB8D-09A1-960B4A0A10D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8088519-481B-253F-BD72-9177CAAA17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C1346-754F-455F-B174-E84FB53D968E}" type="datetimeFigureOut">
              <a:rPr lang="ko-KR" altLang="en-US" smtClean="0"/>
              <a:t>2025-05-1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147623A-44A8-308A-725C-C252017B5C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93E8BB9-5423-4AED-6C9C-D4F1531677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40D77-CA82-4AC0-809E-D018214D5F0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315304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00F3AC60-6D44-13C4-0249-40E874F985E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CC32E643-139A-7D5B-3A8D-7F816B8A45A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531A643-17A1-E787-0AA5-A20D3E25D8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C1346-754F-455F-B174-E84FB53D968E}" type="datetimeFigureOut">
              <a:rPr lang="ko-KR" altLang="en-US" smtClean="0"/>
              <a:t>2025-05-1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9AA3FD1-3012-D1AC-4EFB-306850BF37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1A49936-167D-3317-6D71-B7CCFA3F42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40D77-CA82-4AC0-809E-D018214D5F0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356141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0A79A33-839E-B914-9B27-780BFEBBAD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AB20CACE-6764-AF80-78DA-31C952B9CF1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851C715-3A02-8731-307C-EAF6CBCA03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C1346-754F-455F-B174-E84FB53D968E}" type="datetimeFigureOut">
              <a:rPr lang="ko-KR" altLang="en-US" smtClean="0"/>
              <a:t>2025-05-1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D1EEA36-9BD3-EB4F-2C26-22812B27D5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8748F45-8216-0276-3453-A9F0E46CEC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40D77-CA82-4AC0-809E-D018214D5F0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558049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EDD3FAF-D33B-E5C8-5538-5C571ECDDF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E39C92DB-D0A7-3911-30BC-5CF7B2EF7E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C1D14EC-F100-2275-156E-2100A96E6B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C1346-754F-455F-B174-E84FB53D968E}" type="datetimeFigureOut">
              <a:rPr lang="ko-KR" altLang="en-US" smtClean="0"/>
              <a:t>2025-05-1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ED348D5-1E7B-7B78-9521-A5F345AAD1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F9EB359-6E9A-A50D-2F77-EEB1875C9C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40D77-CA82-4AC0-809E-D018214D5F0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650642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60C3313-1DE9-99E2-8E60-9B37BC76B3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E7D66857-6F6F-60A1-D14E-77701973292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761151DF-86C5-4855-1812-930D568CAF1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9F25018D-C84B-24E0-D277-A72408AC35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C1346-754F-455F-B174-E84FB53D968E}" type="datetimeFigureOut">
              <a:rPr lang="ko-KR" altLang="en-US" smtClean="0"/>
              <a:t>2025-05-19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3E57E1C8-C2D4-18EA-08D3-7C98666365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1AC7C79C-7E9E-99E7-C67A-B6AE2BE631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40D77-CA82-4AC0-809E-D018214D5F0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81605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F5CD25E-3873-7FFE-9C5B-C491F097A0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881E8106-B725-A6F3-D9B3-C000DE94B5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52B3D418-0FD2-1D93-D467-7720FBFF708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E948334F-EFF5-2366-F138-156DB3502D0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B48A2235-D087-B76F-1EBA-2BC4D5A6F0D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3FABB9D8-36FC-FCB8-92F0-1437624D31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C1346-754F-455F-B174-E84FB53D968E}" type="datetimeFigureOut">
              <a:rPr lang="ko-KR" altLang="en-US" smtClean="0"/>
              <a:t>2025-05-19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B5BAAB01-AE99-E09B-EDEB-A9579C4879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51F267F7-4A69-9EA1-4941-E69C548D6D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40D77-CA82-4AC0-809E-D018214D5F0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736301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FE03A41-4190-7CFF-ED0C-139955E9CE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1060DD3F-6B2B-4852-F161-5319886F8E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C1346-754F-455F-B174-E84FB53D968E}" type="datetimeFigureOut">
              <a:rPr lang="ko-KR" altLang="en-US" smtClean="0"/>
              <a:t>2025-05-19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B01365C4-3408-BB5A-50B7-1912257604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A6F3133E-B034-C327-A3F4-E01DC7D1B5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40D77-CA82-4AC0-809E-D018214D5F0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866399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5DC0D4B6-4D06-A1D3-674F-A8E088F18D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C1346-754F-455F-B174-E84FB53D968E}" type="datetimeFigureOut">
              <a:rPr lang="ko-KR" altLang="en-US" smtClean="0"/>
              <a:t>2025-05-19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C1F61B8F-AA24-426F-9CB4-E24A318BD2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E8838FCC-5ACE-EA66-021A-A69E173137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40D77-CA82-4AC0-809E-D018214D5F0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426146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21DFB47-336A-12A5-701F-FE6538361E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58167D9C-4105-14D3-5C95-558B04A39C4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276E390A-C7A6-956A-0D4E-D5715759A95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E122DC47-8362-1345-5CAF-8233D7C069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C1346-754F-455F-B174-E84FB53D968E}" type="datetimeFigureOut">
              <a:rPr lang="ko-KR" altLang="en-US" smtClean="0"/>
              <a:t>2025-05-19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AD49048C-656A-1D4C-C64A-ACED47A426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0BE4CC6E-E250-5DD8-F904-5B52FE85F7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40D77-CA82-4AC0-809E-D018214D5F0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695410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4340E98-C693-BC14-922F-3C3087A4EF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4466A6D7-1546-150C-C5EA-A463C80BB01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A3AD20F8-83D4-B674-1712-C701B3898FB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63FD1EC9-C439-4A2B-8877-9E4D775C4C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C1346-754F-455F-B174-E84FB53D968E}" type="datetimeFigureOut">
              <a:rPr lang="ko-KR" altLang="en-US" smtClean="0"/>
              <a:t>2025-05-19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66D0E397-0534-837B-7661-39D0380C80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D0961BA4-E47E-EE20-978C-34B5BB21BA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40D77-CA82-4AC0-809E-D018214D5F0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915680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89C6FF4E-3AFA-3753-AF30-6331262D29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C036CA2A-1737-2357-3681-C238E0E253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2792CCD-4E42-5393-7929-D2C9AD3F63D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9DC1346-754F-455F-B174-E84FB53D968E}" type="datetimeFigureOut">
              <a:rPr lang="ko-KR" altLang="en-US" smtClean="0"/>
              <a:t>2025-05-1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EF618C2-8D39-C991-5430-C6D0B41666E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B2416C3D-D4AE-5892-6B94-79F3F2B174F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E440D77-CA82-4AC0-809E-D018214D5F0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35454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>
            <a:extLst>
              <a:ext uri="{FF2B5EF4-FFF2-40B4-BE49-F238E27FC236}">
                <a16:creationId xmlns:a16="http://schemas.microsoft.com/office/drawing/2014/main" id="{79CAA958-11F5-8050-FB4C-06A6BFAB1921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25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53735" y="992145"/>
            <a:ext cx="5884529" cy="4707623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A8AA564D-44B7-77DD-F563-B87B64381E3A}"/>
              </a:ext>
            </a:extLst>
          </p:cNvPr>
          <p:cNvSpPr txBox="1"/>
          <p:nvPr/>
        </p:nvSpPr>
        <p:spPr>
          <a:xfrm>
            <a:off x="180780" y="201880"/>
            <a:ext cx="24673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Supplement</a:t>
            </a:r>
            <a:r>
              <a:rPr lang="ko-KR" altLang="en-US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Figure 1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3A34D4F-2268-B4A9-3394-8A8340A3D296}"/>
              </a:ext>
            </a:extLst>
          </p:cNvPr>
          <p:cNvSpPr txBox="1"/>
          <p:nvPr/>
        </p:nvSpPr>
        <p:spPr>
          <a:xfrm>
            <a:off x="326572" y="5768889"/>
            <a:ext cx="11728579" cy="8872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1" hangingPunct="1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 Figure 1.</a:t>
            </a:r>
            <a:r>
              <a: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Histopathologic features of the renal biopsy. Small artery showing endothelial swelling and destruction of wall due to lymphocyte dominant inflammatory infiltrates (PAS stain, original magnification: x400). 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164879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맑은 고딕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맑은 고딕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39</Words>
  <Application>Microsoft Office PowerPoint</Application>
  <PresentationFormat>와이드스크린</PresentationFormat>
  <Paragraphs>3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yung Pyo Kang</dc:creator>
  <cp:lastModifiedBy>Kyung Pyo Kang</cp:lastModifiedBy>
  <cp:revision>1</cp:revision>
  <dcterms:created xsi:type="dcterms:W3CDTF">2025-05-18T12:11:33Z</dcterms:created>
  <dcterms:modified xsi:type="dcterms:W3CDTF">2025-05-19T14:37:44Z</dcterms:modified>
</cp:coreProperties>
</file>